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662" r:id="rId2"/>
    <p:sldId id="261" r:id="rId3"/>
    <p:sldId id="267" r:id="rId4"/>
    <p:sldId id="262" r:id="rId5"/>
    <p:sldId id="664" r:id="rId6"/>
    <p:sldId id="663" r:id="rId7"/>
  </p:sldIdLst>
  <p:sldSz cx="12192000" cy="6858000"/>
  <p:notesSz cx="6858000" cy="9144000"/>
  <p:defaultTextStyle>
    <a:defPPr>
      <a:defRPr lang="en-CH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298"/>
    <p:restoredTop sz="94558"/>
  </p:normalViewPr>
  <p:slideViewPr>
    <p:cSldViewPr snapToGrid="0" snapToObjects="1">
      <p:cViewPr varScale="1">
        <p:scale>
          <a:sx n="121" d="100"/>
          <a:sy n="121" d="100"/>
        </p:scale>
        <p:origin x="760" y="1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28303D9-E37B-664B-8157-484C5A93DFC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F7595F41-019B-8546-836E-BB82536192B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EFCFA3-CC3D-464E-A8C5-4B73E771091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4435B22-1BD1-FC4C-8760-58CD3DC237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58A0F62-201B-2149-9221-E8A1DE5703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502203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500FF6-77BC-7041-9D66-1FCDFB004A9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C7A808F-CD81-304A-91E6-48176792511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012E65-64CA-784C-A0AF-903A3E7D3A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2BE50-171A-8B44-A08A-2EE0A2422B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46AE1DC-3083-7F46-B367-5B3A7E0E023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7329541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2E213FAA-D80C-384C-B9E4-BBBDB495A18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C4E314F-D39D-6149-BDCC-C45C13377F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80F4155-ED7C-3C45-9607-3A803F51D73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E3F826C-D036-1F42-9585-BCE0C6E750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DEA7620-93C3-0948-B2AA-D3651EB797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935685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E7D35F0-2BE0-4C41-B961-74C6D9A187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BF57CBD-7C6D-8549-847E-52C0E6AD5F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87AF98-CC77-344A-A3D9-5AF369E732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D546873-002F-E543-8648-731997DEAC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8B45038-0D2B-FB49-BA2A-407DCE3307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37874118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F6954B-3C84-314A-8DB3-E295104F46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B57810F6-E77A-E845-A982-00FB856B65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541C89A-B2DC-2943-BD03-71BBDFEE8BD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C1E1987-04FD-F946-848B-8DD109AF338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27BF6D8-701E-8E47-80A3-648B1D74CC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5439368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3ED846-4BFC-8A4B-9AB5-F6638A575F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3A0686D-5A58-534F-8D4B-BB764B09A83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55A9A6C-BBB1-D741-914D-F15C493F7E3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F117B4C-E90A-9944-8F47-EBA7F06EB8F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00E8DF-F0FC-0641-AE72-B57E16D8AD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BC1E9B7-2C29-5A46-98B5-0D5AB674D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2296030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0FBD248-2424-434C-B435-E1199D1CD80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3FE4228-0B72-814D-A587-50A6BB6EC8C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D4040B0-2DDE-2A4E-A410-9974B3D3AF6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8CCD782B-260D-2A4B-AE21-F2A6373E669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571D4B83-1EAE-3441-A82A-D2750AA37752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234B1DB0-EAA3-D349-8B92-DC3B99A8CF0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7ACEE44A-18CD-0F41-8433-0B054ED259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1230FDCF-8D57-2C44-80E3-8395FD0C05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100964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9B88D7E-8783-4742-A9E5-1211FE23DA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BADBFEC-68D2-AB48-89F4-015B014A0A8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C98D495-6B41-B846-8CC9-A38ACC35092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8B4E3312-DCB2-6A4F-952B-54BE23E1FF9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28964675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35EFE61-559B-3B4E-A37A-710958CA79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9EC00F8-91D5-BA44-855A-22556D6F790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A44DCE8-F91E-C942-9B70-2602E73070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83554444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9FBC7A-96DE-EA47-A34F-1F327616D7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8611CFC-7E83-7F47-B9A5-479403CA96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CB1B44-1D26-C447-9A7D-862C794F515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435E7D3-4630-BD46-B208-EE7B326791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A873CCF-974E-EF4F-9E2C-46D96238476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FB2CFA-A8E1-604B-8844-8E126EB6B6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381169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13903D-385A-E947-8B3C-8B6FC0FD63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4CA996F3-48FD-8644-9574-356D7251252F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H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801723B-E66E-214D-8ECA-0B185D5E573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3D14DA6-762A-744B-86B0-5A60179F5C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C7C9715-00D4-EF4F-908B-80ABA16E6A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H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A5A99B7-E4F4-9E47-AA60-8CF9C71848E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15458127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13DC55C8-4ADA-A64F-91DB-44A36B1E97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CH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FC3D4C1-67B4-2E4F-97EF-7112EEA259D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CH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57310EF-D7FC-2848-97AC-858CA4ACCD3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513DDE-82D2-0E49-A335-06C96D1B98D9}" type="datetimeFigureOut">
              <a:rPr lang="en-CH" smtClean="0"/>
              <a:t>29.09.22</a:t>
            </a:fld>
            <a:endParaRPr lang="en-CH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9C61A8E-59C0-8E41-981F-3D8F3951F9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H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77D9B19-3D81-A84D-94D5-F7D43FCE166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D350BD-E242-5C4F-ADBA-8DFD5959A934}" type="slidenum">
              <a:rPr lang="en-CH" smtClean="0"/>
              <a:t>‹#›</a:t>
            </a:fld>
            <a:endParaRPr lang="en-CH"/>
          </a:p>
        </p:txBody>
      </p:sp>
    </p:spTree>
    <p:extLst>
      <p:ext uri="{BB962C8B-B14F-4D97-AF65-F5344CB8AC3E}">
        <p14:creationId xmlns:p14="http://schemas.microsoft.com/office/powerpoint/2010/main" val="33731715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H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emf"/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emf"/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emf"/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11.emf"/><Relationship Id="rId4" Type="http://schemas.openxmlformats.org/officeDocument/2006/relationships/image" Target="../media/image10.emf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emf"/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614D95D5-2992-4547-B992-9715A619A297}"/>
              </a:ext>
            </a:extLst>
          </p:cNvPr>
          <p:cNvSpPr txBox="1"/>
          <p:nvPr/>
        </p:nvSpPr>
        <p:spPr>
          <a:xfrm>
            <a:off x="553232" y="4788535"/>
            <a:ext cx="11085535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S5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Validation of PM data on Csps contributions to </a:t>
            </a:r>
            <a:r>
              <a:rPr lang="en-US" sz="1400" i="1" dirty="0" err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Lm</a:t>
            </a:r>
            <a:r>
              <a:rPr lang="en-US" sz="1400" i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PEA stress tolerance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ented are area under the curve (AUC) graphs showing </a:t>
            </a:r>
            <a:r>
              <a:rPr lang="en-US" sz="1400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rowth under PEA stress in BHI of WT strains (LI: LL195, N2306 and LII: N1546)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and their 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p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letion mutants at 37</a:t>
            </a: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</a:t>
            </a:r>
            <a:r>
              <a:rPr lang="en-GB" sz="1400" b="1" baseline="30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∗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dicates statistically significant difference between the strains (</a:t>
            </a:r>
            <a:r>
              <a:rPr lang="en-GB" sz="14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GB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&lt; 0.05) based on Tukey’s post-hoc test pairwise comparison following one-way ANOVA .</a:t>
            </a:r>
            <a:endParaRPr lang="en-CH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F6B02505-715F-D54B-9B76-10F68A7DE71B}"/>
              </a:ext>
            </a:extLst>
          </p:cNvPr>
          <p:cNvSpPr txBox="1"/>
          <p:nvPr/>
        </p:nvSpPr>
        <p:spPr>
          <a:xfrm>
            <a:off x="1021945" y="583312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F251996D-5400-B24E-9D57-4DB11CA73664}"/>
              </a:ext>
            </a:extLst>
          </p:cNvPr>
          <p:cNvSpPr txBox="1"/>
          <p:nvPr/>
        </p:nvSpPr>
        <p:spPr>
          <a:xfrm>
            <a:off x="3870075" y="587947"/>
            <a:ext cx="5245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Palatino Linotype" panose="02040502050505030304" pitchFamily="18" charset="0"/>
              </a:rPr>
              <a:t>(B)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64C65556-632D-BC4A-BA7E-050589BC23D5}"/>
              </a:ext>
            </a:extLst>
          </p:cNvPr>
          <p:cNvSpPr txBox="1"/>
          <p:nvPr/>
        </p:nvSpPr>
        <p:spPr>
          <a:xfrm>
            <a:off x="7116939" y="583312"/>
            <a:ext cx="54053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Palatino Linotype" panose="02040502050505030304" pitchFamily="18" charset="0"/>
              </a:rPr>
              <a:t>(C)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FF7C100D-FE0B-E340-9E1D-614C1E325F2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38905" y="1039279"/>
            <a:ext cx="2489200" cy="29464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69B1F293-322A-6641-8C6F-36F0391DBB23}"/>
              </a:ext>
            </a:extLst>
          </p:cNvPr>
          <p:cNvSpPr txBox="1"/>
          <p:nvPr/>
        </p:nvSpPr>
        <p:spPr>
          <a:xfrm>
            <a:off x="3315758" y="2729241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dirty="0"/>
              <a:t>*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A55C96E7-C01F-994C-89CC-5A2B31A784E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394578" y="1037915"/>
            <a:ext cx="2504726" cy="2951999"/>
          </a:xfrm>
          <a:prstGeom prst="rect">
            <a:avLst/>
          </a:prstGeom>
        </p:spPr>
      </p:pic>
      <p:sp>
        <p:nvSpPr>
          <p:cNvPr id="18" name="TextBox 17">
            <a:extLst>
              <a:ext uri="{FF2B5EF4-FFF2-40B4-BE49-F238E27FC236}">
                <a16:creationId xmlns:a16="http://schemas.microsoft.com/office/drawing/2014/main" id="{B28C2429-20F7-EB41-B1FE-FFF2DCB6587B}"/>
              </a:ext>
            </a:extLst>
          </p:cNvPr>
          <p:cNvSpPr txBox="1"/>
          <p:nvPr/>
        </p:nvSpPr>
        <p:spPr>
          <a:xfrm>
            <a:off x="5110419" y="175131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dirty="0"/>
              <a:t>*</a:t>
            </a:r>
          </a:p>
        </p:txBody>
      </p:sp>
      <p:pic>
        <p:nvPicPr>
          <p:cNvPr id="19" name="Picture 18">
            <a:extLst>
              <a:ext uri="{FF2B5EF4-FFF2-40B4-BE49-F238E27FC236}">
                <a16:creationId xmlns:a16="http://schemas.microsoft.com/office/drawing/2014/main" id="{E985CC6D-9837-264E-97A3-0A8B629AE81F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7657472" y="1037915"/>
            <a:ext cx="2535858" cy="2951999"/>
          </a:xfrm>
          <a:prstGeom prst="rect">
            <a:avLst/>
          </a:prstGeom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3B0C4CF8-F04A-D24E-80DA-36E72C4FD1FF}"/>
              </a:ext>
            </a:extLst>
          </p:cNvPr>
          <p:cNvSpPr txBox="1"/>
          <p:nvPr/>
        </p:nvSpPr>
        <p:spPr>
          <a:xfrm>
            <a:off x="9669544" y="280833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dirty="0"/>
              <a:t>*</a:t>
            </a:r>
          </a:p>
        </p:txBody>
      </p:sp>
    </p:spTree>
    <p:extLst>
      <p:ext uri="{BB962C8B-B14F-4D97-AF65-F5344CB8AC3E}">
        <p14:creationId xmlns:p14="http://schemas.microsoft.com/office/powerpoint/2010/main" val="19974533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99EDE1A-CD0C-984C-92CE-3C392C8C743A}"/>
              </a:ext>
            </a:extLst>
          </p:cNvPr>
          <p:cNvSpPr txBox="1"/>
          <p:nvPr/>
        </p:nvSpPr>
        <p:spPr>
          <a:xfrm>
            <a:off x="149902" y="5960178"/>
            <a:ext cx="1175136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S6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Csps contribute to </a:t>
            </a:r>
            <a:r>
              <a:rPr lang="en-US" sz="1400" i="1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Lm</a:t>
            </a:r>
            <a:r>
              <a:rPr lang="en-US" sz="14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rowth under cold stress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ented are graphs showing AUC comparison of EGDe, N2306, N1546, LL195, N16-0044, LMNC318, LMNC326 and their respective 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p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letion mutants and complements (only EGDe) in BHI at 4</a:t>
            </a: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Bars for each strain and its corresponding mutants share the same color. The WT is denoted by the dotted line, while complements are denoted by ,A/B/D (for example, ,A represents pPL2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spA)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. * P &lt; 0.05 relative to the respective WT strains. </a:t>
            </a:r>
            <a:endParaRPr lang="en-CH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F4E080DF-5947-4B47-8AD7-7607A443E4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6000" y="2842755"/>
            <a:ext cx="9900000" cy="2937754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21C1AEA1-008B-1544-B4E9-F4851A136EA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6000" y="60682"/>
            <a:ext cx="9900000" cy="2927168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2CCAC9ED-0031-AD4F-96EA-C1BBF505611B}"/>
              </a:ext>
            </a:extLst>
          </p:cNvPr>
          <p:cNvSpPr txBox="1"/>
          <p:nvPr/>
        </p:nvSpPr>
        <p:spPr>
          <a:xfrm>
            <a:off x="524657" y="26982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2DC3C86-9264-8F41-95B5-31951290461B}"/>
              </a:ext>
            </a:extLst>
          </p:cNvPr>
          <p:cNvSpPr txBox="1"/>
          <p:nvPr/>
        </p:nvSpPr>
        <p:spPr>
          <a:xfrm>
            <a:off x="524657" y="299803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b="1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391037562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B4178D39-CA46-5043-88D0-B59B8E277C81}"/>
              </a:ext>
            </a:extLst>
          </p:cNvPr>
          <p:cNvSpPr txBox="1"/>
          <p:nvPr/>
        </p:nvSpPr>
        <p:spPr>
          <a:xfrm>
            <a:off x="613775" y="5660875"/>
            <a:ext cx="11085535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S7A-B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Csps contribute to </a:t>
            </a:r>
            <a:r>
              <a:rPr lang="en-US" sz="14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L. monocytogenes 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rowth under cold stress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Using complemented strains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GDe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_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pABD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::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PL2-cspA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and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GDe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_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∆</a:t>
            </a:r>
            <a:r>
              <a:rPr lang="en-US" sz="1400" i="1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pA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­::pPL2-cspA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, we restored cold growth in the parent mutants, confirming that </a:t>
            </a:r>
            <a:r>
              <a:rPr lang="en-US" sz="1400" dirty="0" err="1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pA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s the most critical Csp for cold stress tolerance. Presented are graphs showing relative area under the curve (AUC) comparison of EGDe and its 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p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letion mutants and complements in BHI at 8</a:t>
            </a: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. Growth of all mutants is significantly lower compared to the WT (EGDe) (* P &lt; 0.05). The WT is denoted by the dotted line, while complements are denoted by +A/B/D (for example, +A represents pPL2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spA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lementation). </a:t>
            </a:r>
            <a:endParaRPr lang="en-CH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C7454E5A-8B2D-1F4F-91CA-293B97AD3D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13775" y="777437"/>
            <a:ext cx="5677708" cy="4320000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07768562-0809-1442-B6EC-F7FD87F08B2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7280562" y="777437"/>
            <a:ext cx="3511163" cy="43200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68777E98-98C3-3D41-AA76-FB701057F421}"/>
              </a:ext>
            </a:extLst>
          </p:cNvPr>
          <p:cNvSpPr txBox="1"/>
          <p:nvPr/>
        </p:nvSpPr>
        <p:spPr>
          <a:xfrm>
            <a:off x="473305" y="210776"/>
            <a:ext cx="553357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Palatino Linotype" panose="02040502050505030304" pitchFamily="18" charset="0"/>
              </a:rPr>
              <a:t>(A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6B5CE586-A701-1847-B530-5705A2CD90C2}"/>
              </a:ext>
            </a:extLst>
          </p:cNvPr>
          <p:cNvSpPr txBox="1"/>
          <p:nvPr/>
        </p:nvSpPr>
        <p:spPr>
          <a:xfrm>
            <a:off x="6756059" y="210776"/>
            <a:ext cx="524503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sz="2000" b="1" dirty="0">
                <a:latin typeface="Palatino Linotype" panose="02040502050505030304" pitchFamily="18" charset="0"/>
              </a:rPr>
              <a:t>(B)</a:t>
            </a:r>
          </a:p>
        </p:txBody>
      </p:sp>
    </p:spTree>
    <p:extLst>
      <p:ext uri="{BB962C8B-B14F-4D97-AF65-F5344CB8AC3E}">
        <p14:creationId xmlns:p14="http://schemas.microsoft.com/office/powerpoint/2010/main" val="216749820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Box 5">
            <a:extLst>
              <a:ext uri="{FF2B5EF4-FFF2-40B4-BE49-F238E27FC236}">
                <a16:creationId xmlns:a16="http://schemas.microsoft.com/office/drawing/2014/main" id="{E54B2136-DB0C-254B-B65E-EA3960CDC197}"/>
              </a:ext>
            </a:extLst>
          </p:cNvPr>
          <p:cNvSpPr txBox="1"/>
          <p:nvPr/>
        </p:nvSpPr>
        <p:spPr>
          <a:xfrm>
            <a:off x="190358" y="186452"/>
            <a:ext cx="5052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b="1" dirty="0">
                <a:latin typeface="Palatino Linotype" panose="02040502050505030304" pitchFamily="18" charset="0"/>
              </a:rPr>
              <a:t>(C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2472D1F8-788D-2942-9974-6C3C00432397}"/>
              </a:ext>
            </a:extLst>
          </p:cNvPr>
          <p:cNvSpPr txBox="1"/>
          <p:nvPr/>
        </p:nvSpPr>
        <p:spPr>
          <a:xfrm>
            <a:off x="4274465" y="186452"/>
            <a:ext cx="530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b="1" dirty="0">
                <a:latin typeface="Palatino Linotype" panose="02040502050505030304" pitchFamily="18" charset="0"/>
              </a:rPr>
              <a:t>(D)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AC85577D-910C-F348-9FFC-93CE26C06CA4}"/>
              </a:ext>
            </a:extLst>
          </p:cNvPr>
          <p:cNvSpPr txBox="1"/>
          <p:nvPr/>
        </p:nvSpPr>
        <p:spPr>
          <a:xfrm>
            <a:off x="190358" y="3477692"/>
            <a:ext cx="4780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b="1" dirty="0">
                <a:latin typeface="Palatino Linotype" panose="02040502050505030304" pitchFamily="18" charset="0"/>
              </a:rPr>
              <a:t>(E)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14DDE388-C4CD-F64D-9BC6-E5B8A905021F}"/>
              </a:ext>
            </a:extLst>
          </p:cNvPr>
          <p:cNvSpPr txBox="1"/>
          <p:nvPr/>
        </p:nvSpPr>
        <p:spPr>
          <a:xfrm>
            <a:off x="4274465" y="3477692"/>
            <a:ext cx="4667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b="1" dirty="0">
                <a:latin typeface="Palatino Linotype" panose="02040502050505030304" pitchFamily="18" charset="0"/>
              </a:rPr>
              <a:t>(F)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F093C2E5-7BFC-F744-9ECD-49D6E786CAB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95625" y="218409"/>
            <a:ext cx="3458451" cy="2988000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15C9CFA8-94CE-6A41-A821-7F6A0B86C85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136532" y="218409"/>
            <a:ext cx="3089719" cy="2988000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4D924981-8458-404E-8B94-39F3D0D2CFBE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20214" y="3620057"/>
            <a:ext cx="3013538" cy="2988000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6C0B040E-E8EF-9849-9310-A1459A9435D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5289808" y="3620057"/>
            <a:ext cx="2975231" cy="2988000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65EDA09C-3CED-AC42-BB00-48017678FFD8}"/>
              </a:ext>
            </a:extLst>
          </p:cNvPr>
          <p:cNvSpPr txBox="1"/>
          <p:nvPr/>
        </p:nvSpPr>
        <p:spPr>
          <a:xfrm>
            <a:off x="8747372" y="1236604"/>
            <a:ext cx="3089719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S7C-D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Impact of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csp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deletion on growth under cold stress varies with strain and molecular subtype. 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ented are graphs showing relative area under the curve (AUC) comparison of WT strains and their respective </a:t>
            </a:r>
            <a:r>
              <a:rPr lang="en-US" sz="1200" i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p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letion mutants at 8</a:t>
            </a:r>
            <a:r>
              <a:rPr lang="en-US" sz="1200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 in BHI during at day 5 of incubation.</a:t>
            </a:r>
            <a:r>
              <a:rPr lang="en-US" sz="1200" b="1" baseline="30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∗</a:t>
            </a:r>
            <a:r>
              <a:rPr lang="en-US" sz="12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Indicates statistically significant difference between the mutant and its respective WT strain (P &lt; 0.05).</a:t>
            </a:r>
            <a:endParaRPr lang="en-CH" sz="12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2704580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extBox 2">
            <a:extLst>
              <a:ext uri="{FF2B5EF4-FFF2-40B4-BE49-F238E27FC236}">
                <a16:creationId xmlns:a16="http://schemas.microsoft.com/office/drawing/2014/main" id="{799EDE1A-CD0C-984C-92CE-3C392C8C743A}"/>
              </a:ext>
            </a:extLst>
          </p:cNvPr>
          <p:cNvSpPr txBox="1"/>
          <p:nvPr/>
        </p:nvSpPr>
        <p:spPr>
          <a:xfrm>
            <a:off x="149902" y="5932042"/>
            <a:ext cx="1148886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Figure S8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. Csps contribute to </a:t>
            </a:r>
            <a:r>
              <a:rPr lang="en-US" sz="1400" i="1" dirty="0" err="1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Lm</a:t>
            </a:r>
            <a:r>
              <a:rPr lang="en-US" sz="1400" i="1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 </a:t>
            </a:r>
            <a:r>
              <a:rPr lang="en-US" sz="1400" dirty="0"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growth under dual cold and osmotic stress.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Presented are graphs showing AUC comparison of EGDe, N2306, N1546, LL195, N16-0044, LMNC318, LMNC326 and their respective 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sp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deletion mutants and complements (only EGDe) in BHI at 8</a:t>
            </a:r>
            <a:r>
              <a:rPr lang="en-US" sz="1400" baseline="300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 supplemented with 6.5% NaCl. Bars for each strain and its corresponding mutants share the same color. The WT is denoted by the dotted line, while complements are denoted by ,A/B/D (for example ,A represents pPL2</a:t>
            </a:r>
            <a:r>
              <a:rPr lang="en-US" sz="1400" i="1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cspA </a:t>
            </a:r>
            <a:r>
              <a:rPr lang="en-US" sz="1400" dirty="0">
                <a:latin typeface="Times New Roman" panose="0202060305040502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omplementation). * P &lt; 0.05 relative to the respective WT strains.</a:t>
            </a:r>
            <a:endParaRPr lang="en-CH" sz="1400" dirty="0"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2CCAC9ED-0031-AD4F-96EA-C1BBF505611B}"/>
              </a:ext>
            </a:extLst>
          </p:cNvPr>
          <p:cNvSpPr txBox="1"/>
          <p:nvPr/>
        </p:nvSpPr>
        <p:spPr>
          <a:xfrm>
            <a:off x="524657" y="269826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b="1" dirty="0"/>
              <a:t>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2DC3C86-9264-8F41-95B5-31951290461B}"/>
              </a:ext>
            </a:extLst>
          </p:cNvPr>
          <p:cNvSpPr txBox="1"/>
          <p:nvPr/>
        </p:nvSpPr>
        <p:spPr>
          <a:xfrm>
            <a:off x="524657" y="2998032"/>
            <a:ext cx="31451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CH" b="1" dirty="0"/>
              <a:t>B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3D20EC87-9B23-A541-BFC1-DB4D984659A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46000" y="0"/>
            <a:ext cx="9900000" cy="2939063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3AB7E978-81DA-E84E-8709-40956812953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46000" y="2941827"/>
            <a:ext cx="9900000" cy="288897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0213304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Diagram, schematic&#10;&#10;Description automatically generated">
            <a:extLst>
              <a:ext uri="{FF2B5EF4-FFF2-40B4-BE49-F238E27FC236}">
                <a16:creationId xmlns:a16="http://schemas.microsoft.com/office/drawing/2014/main" id="{EE7A200A-4445-BD4A-B213-CC03D8008E5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80154" y="87682"/>
            <a:ext cx="7809456" cy="5579800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0D43ED4D-F609-6F43-A696-157920B0108E}"/>
              </a:ext>
            </a:extLst>
          </p:cNvPr>
          <p:cNvSpPr txBox="1"/>
          <p:nvPr/>
        </p:nvSpPr>
        <p:spPr>
          <a:xfrm>
            <a:off x="496866" y="5903893"/>
            <a:ext cx="11427912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Bef>
                <a:spcPts val="600"/>
              </a:spcBef>
              <a:spcAft>
                <a:spcPts val="1200"/>
              </a:spcAft>
            </a:pP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Supplementary </a:t>
            </a:r>
            <a:r>
              <a:rPr lang="en-US" sz="1400" b="1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igure S9. </a:t>
            </a:r>
            <a:r>
              <a:rPr lang="en-US" sz="1400" b="1" dirty="0">
                <a:solidFill>
                  <a:srgbClr val="000000"/>
                </a:solidFill>
                <a:latin typeface="Times New Roman" panose="02020603050405020304" pitchFamily="18" charset="0"/>
                <a:ea typeface="MS Mincho" panose="02020609040205080304" pitchFamily="49" charset="-128"/>
                <a:cs typeface="Times New Roman" panose="02020603050405020304" pitchFamily="18" charset="0"/>
              </a:rPr>
              <a:t>Folate biosynthesis </a:t>
            </a:r>
            <a:r>
              <a:rPr lang="en-US" sz="140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pathway map.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Using a </a:t>
            </a:r>
            <a:r>
              <a:rPr lang="en-US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DuctApe</a:t>
            </a:r>
            <a:r>
              <a:rPr lang="en-US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based phenome-genome link analysis we identified potential Csp targets. </a:t>
            </a:r>
            <a:r>
              <a:rPr lang="en-GB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oxes represent reactions while circles represent compounds. </a:t>
            </a:r>
            <a:r>
              <a:rPr lang="en-GB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ore </a:t>
            </a:r>
            <a:r>
              <a:rPr lang="en-GB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reactions found in the strains are coloured blue, y</a:t>
            </a:r>
            <a:r>
              <a:rPr lang="en-GB" sz="1400" dirty="0">
                <a:solidFill>
                  <a:srgbClr val="000000"/>
                </a:solidFill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llow- or orange-coloured boxes highlight enzymes which at least one strain lacks. C</a:t>
            </a:r>
            <a:r>
              <a:rPr lang="en-GB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ompounds present in PM plates are filled with </a:t>
            </a:r>
            <a:r>
              <a:rPr lang="en-GB" sz="14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gray</a:t>
            </a:r>
            <a:r>
              <a:rPr lang="en-GB" sz="14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endParaRPr lang="en-CH" sz="1400" dirty="0">
              <a:effectLst/>
              <a:latin typeface="Times New Roman" panose="02020603050405020304" pitchFamily="18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417640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46</TotalTime>
  <Words>590</Words>
  <Application>Microsoft Macintosh PowerPoint</Application>
  <PresentationFormat>Widescreen</PresentationFormat>
  <Paragraphs>22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Palatino Linotype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Francis Muchaamba</dc:creator>
  <cp:lastModifiedBy>Francis Muchaamba</cp:lastModifiedBy>
  <cp:revision>51</cp:revision>
  <dcterms:created xsi:type="dcterms:W3CDTF">2021-10-17T23:34:35Z</dcterms:created>
  <dcterms:modified xsi:type="dcterms:W3CDTF">2022-09-29T09:57:31Z</dcterms:modified>
</cp:coreProperties>
</file>